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wmf" ContentType="image/x-wmf"/>
  <Override PartName="/ppt/embeddings/oleObject1.xlsx" ContentType="application/vnd.openxmlformats-officedocument.spreadsheetml.shee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622675-DDE5-410E-9395-226FC532504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11B736-503F-4B82-8E67-4D043EB79F1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7880F6-116D-4553-98E8-9E0F03D6C4C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69C8A5-4438-49BE-A240-BA9BE99E3E7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8720F1-2350-4BDC-9812-46F98CF872B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BAC9A5-97E1-40F1-93C0-F7A194BAF3C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62C42B-FB00-40EF-BC61-AB9976A7BE5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4AF836-8BEE-41F6-9FD0-76612C6E333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11BAD3-341F-481E-BDE3-4ED1C98DFDE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BFDF82-5C82-48EA-A88C-A66EF3DDA46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66F253-44C9-4248-BE2C-21E02949406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85B385-9E15-4C5E-B26B-56A8F1A4512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EDDCA3F-B9CE-4361-9D22-7587529AADC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package" Target="../embeddings/oleObject1.xlsx"/><Relationship Id="rId9" Type="http://schemas.openxmlformats.org/officeDocument/2006/relationships/image" Target="../media/image8.wmf"/><Relationship Id="rId1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657720" y="1066680"/>
            <a:ext cx="5346720" cy="6969960"/>
            <a:chOff x="657720" y="1066680"/>
            <a:chExt cx="5346720" cy="6969960"/>
          </a:xfrm>
        </p:grpSpPr>
        <p:sp>
          <p:nvSpPr>
            <p:cNvPr id="42" name=""/>
            <p:cNvSpPr/>
            <p:nvPr/>
          </p:nvSpPr>
          <p:spPr>
            <a:xfrm>
              <a:off x="992520" y="1066680"/>
              <a:ext cx="955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Liver IP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3" name="" descr=""/>
            <p:cNvPicPr/>
            <p:nvPr/>
          </p:nvPicPr>
          <p:blipFill>
            <a:blip r:embed="rId1"/>
            <a:stretch/>
          </p:blipFill>
          <p:spPr>
            <a:xfrm>
              <a:off x="1952640" y="3811680"/>
              <a:ext cx="2514600" cy="458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" descr=""/>
            <p:cNvPicPr/>
            <p:nvPr/>
          </p:nvPicPr>
          <p:blipFill>
            <a:blip r:embed="rId2"/>
            <a:stretch/>
          </p:blipFill>
          <p:spPr>
            <a:xfrm>
              <a:off x="1952640" y="3348000"/>
              <a:ext cx="2514600" cy="392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" descr=""/>
            <p:cNvPicPr/>
            <p:nvPr/>
          </p:nvPicPr>
          <p:blipFill>
            <a:blip r:embed="rId3"/>
            <a:stretch/>
          </p:blipFill>
          <p:spPr>
            <a:xfrm>
              <a:off x="1952640" y="4343400"/>
              <a:ext cx="2514600" cy="351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" descr=""/>
            <p:cNvPicPr/>
            <p:nvPr/>
          </p:nvPicPr>
          <p:blipFill>
            <a:blip r:embed="rId4">
              <a:lum bright="4000"/>
            </a:blip>
            <a:stretch/>
          </p:blipFill>
          <p:spPr>
            <a:xfrm>
              <a:off x="1952640" y="5473800"/>
              <a:ext cx="1295280" cy="345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7" name="" descr=""/>
            <p:cNvPicPr/>
            <p:nvPr/>
          </p:nvPicPr>
          <p:blipFill>
            <a:blip r:embed="rId5">
              <a:lum contrast="50000"/>
            </a:blip>
            <a:stretch/>
          </p:blipFill>
          <p:spPr>
            <a:xfrm>
              <a:off x="1952640" y="5029200"/>
              <a:ext cx="1295280" cy="3841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48" name=""/>
            <p:cNvGrpSpPr/>
            <p:nvPr/>
          </p:nvGrpSpPr>
          <p:grpSpPr>
            <a:xfrm>
              <a:off x="1952640" y="2819520"/>
              <a:ext cx="2514600" cy="457200"/>
              <a:chOff x="1952640" y="2819520"/>
              <a:chExt cx="2514600" cy="457200"/>
            </a:xfrm>
          </p:grpSpPr>
          <p:pic>
            <p:nvPicPr>
              <p:cNvPr id="49" name="" descr=""/>
              <p:cNvPicPr/>
              <p:nvPr/>
            </p:nvPicPr>
            <p:blipFill>
              <a:blip r:embed="rId6"/>
              <a:stretch/>
            </p:blipFill>
            <p:spPr>
              <a:xfrm>
                <a:off x="1952640" y="2819520"/>
                <a:ext cx="1243080" cy="4572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0" name="" descr=""/>
              <p:cNvPicPr/>
              <p:nvPr/>
            </p:nvPicPr>
            <p:blipFill>
              <a:blip r:embed="rId7"/>
              <a:stretch/>
            </p:blipFill>
            <p:spPr>
              <a:xfrm>
                <a:off x="3233880" y="2819520"/>
                <a:ext cx="1233360" cy="45720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51" name=""/>
            <p:cNvSpPr/>
            <p:nvPr/>
          </p:nvSpPr>
          <p:spPr>
            <a:xfrm>
              <a:off x="4494960" y="2957400"/>
              <a:ext cx="1509480" cy="2005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2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</a:rPr>
                <a:t>mTOR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 baseline="30000">
                  <a:solidFill>
                    <a:srgbClr val="000000"/>
                  </a:solidFill>
                  <a:latin typeface="Arial"/>
                </a:rPr>
                <a:t>33</a:t>
              </a:r>
              <a:r>
                <a:rPr b="0" lang="en-US" sz="2000" spc="-1" strike="noStrike">
                  <a:solidFill>
                    <a:srgbClr val="000000"/>
                  </a:solidFill>
                  <a:latin typeface="Arial"/>
                </a:rPr>
                <a:t>P-mTOR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 baseline="30000">
                  <a:solidFill>
                    <a:srgbClr val="000000"/>
                  </a:solidFill>
                  <a:latin typeface="Arial"/>
                </a:rPr>
                <a:t>33</a:t>
              </a:r>
              <a:r>
                <a:rPr b="0" lang="en-US" sz="2000" spc="-1" strike="noStrike">
                  <a:solidFill>
                    <a:srgbClr val="000000"/>
                  </a:solidFill>
                  <a:latin typeface="Arial"/>
                </a:rPr>
                <a:t>P-4E-BP1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</a:rPr>
                <a:t>4E-BP1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3248640" y="5168880"/>
              <a:ext cx="1155960" cy="58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2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</a:rPr>
                <a:t>mTOR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</a:t>
              </a:r>
              <a:r>
                <a:rPr b="0" lang="en-US" sz="2000" spc="-1" strike="noStrike">
                  <a:solidFill>
                    <a:srgbClr val="000000"/>
                  </a:solidFill>
                  <a:latin typeface="Arial"/>
                </a:rPr>
                <a:t>-tubulin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657720" y="2133720"/>
              <a:ext cx="1311480" cy="51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2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</a:rPr>
                <a:t>IgG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2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2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2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2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2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2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</a:rPr>
                <a:t>mTOR Ab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2691000" y="2206800"/>
              <a:ext cx="299520" cy="520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8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2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2035080" y="2282760"/>
              <a:ext cx="35892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2070360" y="1839960"/>
              <a:ext cx="299520" cy="520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8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2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2662200" y="1893960"/>
              <a:ext cx="35892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3313440" y="1828800"/>
              <a:ext cx="299520" cy="520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8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2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3906720" y="1893960"/>
              <a:ext cx="35892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3945240" y="2216160"/>
              <a:ext cx="299520" cy="520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8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2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3287520" y="2286000"/>
              <a:ext cx="35892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2202120" y="1371600"/>
              <a:ext cx="62280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Arial"/>
                </a:rPr>
                <a:t>+/+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3353760" y="1371600"/>
              <a:ext cx="76608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Arial"/>
                </a:rPr>
                <a:t>+/kd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2133720" y="1905120"/>
              <a:ext cx="7617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3355920" y="1905120"/>
              <a:ext cx="9111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 rot="16200000">
              <a:off x="956160" y="3311280"/>
              <a:ext cx="11988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IP: mTOR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1747800" y="2924280"/>
              <a:ext cx="0" cy="11142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 rot="16200000">
              <a:off x="1129320" y="5254200"/>
              <a:ext cx="8528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Lysate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1755720" y="5105520"/>
              <a:ext cx="0" cy="66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 rot="16200000">
              <a:off x="424800" y="6693840"/>
              <a:ext cx="149904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Relative Kinas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Activity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1860480" y="7699320"/>
              <a:ext cx="11210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 baseline="30000">
                  <a:solidFill>
                    <a:srgbClr val="000000"/>
                  </a:solidFill>
                  <a:latin typeface="Arial"/>
                </a:rPr>
                <a:t>33</a:t>
              </a: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P-mTOR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3168000" y="7699320"/>
              <a:ext cx="12247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 baseline="30000">
                  <a:solidFill>
                    <a:srgbClr val="000000"/>
                  </a:solidFill>
                  <a:latin typeface="Arial"/>
                </a:rPr>
                <a:t>33</a:t>
              </a: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P-4E-BP1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73" name=""/>
            <p:cNvGraphicFramePr/>
            <p:nvPr/>
          </p:nvGraphicFramePr>
          <p:xfrm>
            <a:off x="1371600" y="6095880"/>
            <a:ext cx="3200400" cy="1711440"/>
          </p:xfrm>
          <a:graphic>
            <a:graphicData uri="http://schemas.openxmlformats.org/presentationml/2006/ole">
              <p:oleObj progId="Excel.Sheet.12" r:id="rId8" spid="">
                <p:embed/>
                <p:pic>
                  <p:nvPicPr>
                    <p:cNvPr id="74" name="" descr=""/>
                    <p:cNvPicPr/>
                    <p:nvPr/>
                  </p:nvPicPr>
                  <p:blipFill>
                    <a:blip r:embed="rId9"/>
                    <a:stretch/>
                  </p:blipFill>
                  <p:spPr>
                    <a:xfrm>
                      <a:off x="1371600" y="6095880"/>
                      <a:ext cx="3200400" cy="17114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85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3-14T04:30:48Z</dcterms:created>
  <dc:creator>Stupid</dc:creator>
  <dc:description/>
  <dc:language>en-US</dc:language>
  <cp:lastModifiedBy>shorb</cp:lastModifiedBy>
  <dcterms:modified xsi:type="dcterms:W3CDTF">2009-05-07T17:31:07Z</dcterms:modified>
  <cp:revision>109</cp:revision>
  <dc:subject/>
  <dc:title>Slide 1</dc:title>
</cp:coreProperties>
</file>